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2" r:id="rId3"/>
    <p:sldId id="256" r:id="rId4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70" autoAdjust="0"/>
    <p:restoredTop sz="94660"/>
  </p:normalViewPr>
  <p:slideViewPr>
    <p:cSldViewPr snapToGrid="0">
      <p:cViewPr varScale="1">
        <p:scale>
          <a:sx n="90" d="100"/>
          <a:sy n="90" d="100"/>
        </p:scale>
        <p:origin x="52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D0B1E-1901-407B-9E26-BA25A7DA6B35}" type="datetimeFigureOut">
              <a:rPr lang="fr-FR" smtClean="0"/>
              <a:t>20/03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17BBD-69EB-4906-8E62-CA704AB0FF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431503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D0B1E-1901-407B-9E26-BA25A7DA6B35}" type="datetimeFigureOut">
              <a:rPr lang="fr-FR" smtClean="0"/>
              <a:t>20/03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17BBD-69EB-4906-8E62-CA704AB0FF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545870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D0B1E-1901-407B-9E26-BA25A7DA6B35}" type="datetimeFigureOut">
              <a:rPr lang="fr-FR" smtClean="0"/>
              <a:t>20/03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17BBD-69EB-4906-8E62-CA704AB0FF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722345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D0B1E-1901-407B-9E26-BA25A7DA6B35}" type="datetimeFigureOut">
              <a:rPr lang="fr-FR" smtClean="0"/>
              <a:t>20/03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17BBD-69EB-4906-8E62-CA704AB0FF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732152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D0B1E-1901-407B-9E26-BA25A7DA6B35}" type="datetimeFigureOut">
              <a:rPr lang="fr-FR" smtClean="0"/>
              <a:t>20/03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17BBD-69EB-4906-8E62-CA704AB0FF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44191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D0B1E-1901-407B-9E26-BA25A7DA6B35}" type="datetimeFigureOut">
              <a:rPr lang="fr-FR" smtClean="0"/>
              <a:t>20/03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17BBD-69EB-4906-8E62-CA704AB0FF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34568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D0B1E-1901-407B-9E26-BA25A7DA6B35}" type="datetimeFigureOut">
              <a:rPr lang="fr-FR" smtClean="0"/>
              <a:t>20/03/2025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17BBD-69EB-4906-8E62-CA704AB0FF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257484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D0B1E-1901-407B-9E26-BA25A7DA6B35}" type="datetimeFigureOut">
              <a:rPr lang="fr-FR" smtClean="0"/>
              <a:t>20/03/2025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17BBD-69EB-4906-8E62-CA704AB0FF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182772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D0B1E-1901-407B-9E26-BA25A7DA6B35}" type="datetimeFigureOut">
              <a:rPr lang="fr-FR" smtClean="0"/>
              <a:t>20/03/2025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17BBD-69EB-4906-8E62-CA704AB0FF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6406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D0B1E-1901-407B-9E26-BA25A7DA6B35}" type="datetimeFigureOut">
              <a:rPr lang="fr-FR" smtClean="0"/>
              <a:t>20/03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17BBD-69EB-4906-8E62-CA704AB0FF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416178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D0B1E-1901-407B-9E26-BA25A7DA6B35}" type="datetimeFigureOut">
              <a:rPr lang="fr-FR" smtClean="0"/>
              <a:t>20/03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17BBD-69EB-4906-8E62-CA704AB0FF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099479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3D0B1E-1901-407B-9E26-BA25A7DA6B35}" type="datetimeFigureOut">
              <a:rPr lang="fr-FR" smtClean="0"/>
              <a:t>20/03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F17BBD-69EB-4906-8E62-CA704AB0FF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72522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/>
          <p:nvPr/>
        </p:nvPicPr>
        <p:blipFill>
          <a:blip r:embed="rId2"/>
          <a:stretch>
            <a:fillRect/>
          </a:stretch>
        </p:blipFill>
        <p:spPr>
          <a:xfrm>
            <a:off x="1505712" y="785114"/>
            <a:ext cx="9467088" cy="3549142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1356360" y="4595231"/>
            <a:ext cx="9863328" cy="3886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1</a:t>
            </a:r>
            <a:endParaRPr lang="fr-FR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192189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2194560" y="32004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fr-FR"/>
          </a:p>
        </p:txBody>
      </p:sp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137160" y="475488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fr-FR"/>
          </a:p>
        </p:txBody>
      </p:sp>
      <p:graphicFrame>
        <p:nvGraphicFramePr>
          <p:cNvPr id="3" name="Obje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99777345"/>
              </p:ext>
            </p:extLst>
          </p:nvPr>
        </p:nvGraphicFramePr>
        <p:xfrm>
          <a:off x="136525" y="476250"/>
          <a:ext cx="6613525" cy="61325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6989592" imgH="6485428" progId="Prism10.Document">
                  <p:embed/>
                </p:oleObj>
              </mc:Choice>
              <mc:Fallback>
                <p:oleObj name="Prism 10" r:id="rId2" imgW="6989592" imgH="6485428" progId="Prism10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36525" y="476250"/>
                        <a:ext cx="6613525" cy="6132513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Rectangle 4"/>
          <p:cNvSpPr/>
          <p:nvPr/>
        </p:nvSpPr>
        <p:spPr>
          <a:xfrm>
            <a:off x="5900928" y="320039"/>
            <a:ext cx="6096000" cy="292259"/>
          </a:xfrm>
          <a:prstGeom prst="rect">
            <a:avLst/>
          </a:prstGeom>
        </p:spPr>
        <p:txBody>
          <a:bodyPr>
            <a:spAutoFit/>
          </a:bodyPr>
          <a:lstStyle/>
          <a:p>
            <a:pPr marL="457200" algn="just">
              <a:lnSpc>
                <a:spcPct val="115000"/>
              </a:lnSpc>
              <a:spcAft>
                <a:spcPts val="800"/>
              </a:spcAft>
            </a:pP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</a:t>
            </a:r>
            <a:endParaRPr lang="fr-FR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722745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295656" y="125018"/>
            <a:ext cx="6096000" cy="805542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2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raphical abstract</a:t>
            </a:r>
            <a:r>
              <a:rPr lang="en-US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 </a:t>
            </a:r>
            <a:r>
              <a:rPr lang="en-US" sz="2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fr-FR" sz="2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300"/>
              </a:spcAft>
            </a:pPr>
            <a:r>
              <a:rPr lang="en-US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 </a:t>
            </a:r>
            <a:endParaRPr lang="fr-FR" dirty="0">
              <a:solidFill>
                <a:srgbClr val="000000"/>
              </a:solidFill>
              <a:latin typeface="Calibri" panose="020F0502020204030204" pitchFamily="34" charset="0"/>
              <a:ea typeface="Times New Roman" panose="02020603050405020304" pitchFamily="18" charset="0"/>
              <a:cs typeface="Calibri" panose="020F0502020204030204" pitchFamily="34" charset="0"/>
            </a:endParaRPr>
          </a:p>
        </p:txBody>
      </p:sp>
      <p:pic>
        <p:nvPicPr>
          <p:cNvPr id="4" name="Image 3"/>
          <p:cNvPicPr>
            <a:picLocks noChangeAspect="1"/>
          </p:cNvPicPr>
          <p:nvPr/>
        </p:nvPicPr>
        <p:blipFill rotWithShape="1">
          <a:blip r:embed="rId2"/>
          <a:srcRect t="18825" b="20082"/>
          <a:stretch/>
        </p:blipFill>
        <p:spPr>
          <a:xfrm>
            <a:off x="295656" y="930560"/>
            <a:ext cx="11704709" cy="5241639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4C0CE83A-342F-8499-8313-9F0056E16DDC}"/>
              </a:ext>
            </a:extLst>
          </p:cNvPr>
          <p:cNvSpPr/>
          <p:nvPr/>
        </p:nvSpPr>
        <p:spPr>
          <a:xfrm>
            <a:off x="4057840" y="6092189"/>
            <a:ext cx="6096000" cy="292259"/>
          </a:xfrm>
          <a:prstGeom prst="rect">
            <a:avLst/>
          </a:prstGeom>
        </p:spPr>
        <p:txBody>
          <a:bodyPr>
            <a:spAutoFit/>
          </a:bodyPr>
          <a:lstStyle/>
          <a:p>
            <a:pPr marL="457200" algn="just">
              <a:lnSpc>
                <a:spcPct val="115000"/>
              </a:lnSpc>
              <a:spcAft>
                <a:spcPts val="800"/>
              </a:spcAft>
            </a:pP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3</a:t>
            </a:r>
            <a:endParaRPr lang="fr-FR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0091113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42</TotalTime>
  <Words>12</Words>
  <Application>Microsoft Macintosh PowerPoint</Application>
  <PresentationFormat>Grand écran</PresentationFormat>
  <Paragraphs>5</Paragraphs>
  <Slides>3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hème Office</vt:lpstr>
      <vt:lpstr>Prism 10</vt:lpstr>
      <vt:lpstr>Présentation PowerPoint</vt:lpstr>
      <vt:lpstr>Présentation PowerPoint</vt:lpstr>
      <vt:lpstr>Présentation PowerPoint</vt:lpstr>
    </vt:vector>
  </TitlesOfParts>
  <Company>CE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DISDIER Clémence</dc:creator>
  <cp:lastModifiedBy>Henri Benech</cp:lastModifiedBy>
  <cp:revision>54</cp:revision>
  <dcterms:created xsi:type="dcterms:W3CDTF">2024-07-30T06:28:28Z</dcterms:created>
  <dcterms:modified xsi:type="dcterms:W3CDTF">2025-03-20T18:18:01Z</dcterms:modified>
</cp:coreProperties>
</file>